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1700A-056A-44CD-AA3E-7800DEBA22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771084-74B2-4FB6-92FA-D17794278A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81FDA-0D19-439B-BD58-55FE507CE9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9F0E5-14B3-4341-A1C5-690CD8DAA3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2FE7F-7DFF-4492-8AE0-EB8131FB80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B6F43-ED84-41D5-BD1A-E90EBC1A74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7473A-3565-42FD-B868-C517BA2DE3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5B4B0-1174-4158-B084-6681936210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60081-D728-47E6-AE65-786E5180F0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DFBC7-22D9-4D0D-9B05-5DB059DE5E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02F4B-985D-427E-A627-7015B11198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BA5D2-C7A8-41F8-89D1-9171210B3B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E2AF5F-5694-4FB9-AE61-2D7C9C5E28BF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ct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3962520" y="8682120"/>
            <a:ext cx="2666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Times New Roman"/>
              </a:rPr>
              <a:t>Chiron </a:t>
            </a:r>
            <a:r>
              <a:rPr b="1" i="1" lang="fr-FR" sz="1400" spc="-1" strike="noStrike">
                <a:solidFill>
                  <a:srgbClr val="000000"/>
                </a:solidFill>
                <a:latin typeface="Times New Roman"/>
              </a:rPr>
              <a:t>et al</a:t>
            </a:r>
            <a:r>
              <a:rPr b="1" lang="fr-FR" sz="1400" spc="-1" strike="noStrike">
                <a:solidFill>
                  <a:srgbClr val="000000"/>
                </a:solidFill>
                <a:latin typeface="Times New Roman"/>
              </a:rPr>
              <a:t>., Additional File 1</a:t>
            </a:r>
            <a:r>
              <a:rPr b="1" lang="fr-FR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er 40"/>
          <p:cNvGrpSpPr/>
          <p:nvPr/>
        </p:nvGrpSpPr>
        <p:grpSpPr>
          <a:xfrm>
            <a:off x="838080" y="152280"/>
            <a:ext cx="4218120" cy="5787360"/>
            <a:chOff x="838080" y="152280"/>
            <a:chExt cx="4218120" cy="5787360"/>
          </a:xfrm>
        </p:grpSpPr>
        <p:sp>
          <p:nvSpPr>
            <p:cNvPr id="43" name="Text Box 5"/>
            <p:cNvSpPr/>
            <p:nvPr/>
          </p:nvSpPr>
          <p:spPr>
            <a:xfrm>
              <a:off x="2350080" y="152280"/>
              <a:ext cx="1193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Bn-</a:t>
              </a:r>
              <a:r>
                <a:rPr b="1" i="1" lang="fr-FR" sz="1200" spc="-1" strike="noStrike">
                  <a:solidFill>
                    <a:srgbClr val="000000"/>
                  </a:solidFill>
                  <a:latin typeface="Arial"/>
                </a:rPr>
                <a:t>FAE1.1</a:t>
              </a:r>
              <a:r>
                <a:rPr b="1" lang="fr-FR" sz="16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6"/>
            <p:cNvSpPr/>
            <p:nvPr/>
          </p:nvSpPr>
          <p:spPr>
            <a:xfrm>
              <a:off x="3404880" y="128808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23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7"/>
            <p:cNvSpPr/>
            <p:nvPr/>
          </p:nvSpPr>
          <p:spPr>
            <a:xfrm>
              <a:off x="3404880" y="118512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2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8"/>
            <p:cNvSpPr/>
            <p:nvPr/>
          </p:nvSpPr>
          <p:spPr>
            <a:xfrm>
              <a:off x="3404880" y="75564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30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9"/>
            <p:cNvSpPr/>
            <p:nvPr/>
          </p:nvSpPr>
          <p:spPr>
            <a:xfrm>
              <a:off x="1287360" y="488880"/>
              <a:ext cx="122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M   1    2   3   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10"/>
            <p:cNvSpPr/>
            <p:nvPr/>
          </p:nvSpPr>
          <p:spPr>
            <a:xfrm>
              <a:off x="838080" y="2873520"/>
              <a:ext cx="528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143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1"/>
            <p:cNvSpPr/>
            <p:nvPr/>
          </p:nvSpPr>
          <p:spPr>
            <a:xfrm>
              <a:off x="838080" y="2684520"/>
              <a:ext cx="528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14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2"/>
            <p:cNvSpPr/>
            <p:nvPr/>
          </p:nvSpPr>
          <p:spPr>
            <a:xfrm>
              <a:off x="2350080" y="520200"/>
              <a:ext cx="132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G   A   T   C   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3"/>
            <p:cNvSpPr/>
            <p:nvPr/>
          </p:nvSpPr>
          <p:spPr>
            <a:xfrm>
              <a:off x="846360" y="1099080"/>
              <a:ext cx="441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25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4"/>
            <p:cNvSpPr/>
            <p:nvPr/>
          </p:nvSpPr>
          <p:spPr>
            <a:xfrm>
              <a:off x="3404880" y="333612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12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5"/>
            <p:cNvSpPr/>
            <p:nvPr/>
          </p:nvSpPr>
          <p:spPr>
            <a:xfrm>
              <a:off x="3404880" y="263448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14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6"/>
            <p:cNvSpPr/>
            <p:nvPr/>
          </p:nvSpPr>
          <p:spPr>
            <a:xfrm>
              <a:off x="3404880" y="239580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7"/>
            <p:cNvSpPr/>
            <p:nvPr/>
          </p:nvSpPr>
          <p:spPr>
            <a:xfrm>
              <a:off x="3404880" y="360468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1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8"/>
            <p:cNvSpPr/>
            <p:nvPr/>
          </p:nvSpPr>
          <p:spPr>
            <a:xfrm flipH="1">
              <a:off x="1111680" y="1254960"/>
              <a:ext cx="175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19"/>
            <p:cNvSpPr/>
            <p:nvPr/>
          </p:nvSpPr>
          <p:spPr>
            <a:xfrm flipH="1">
              <a:off x="1111680" y="2937960"/>
              <a:ext cx="175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0"/>
            <p:cNvSpPr/>
            <p:nvPr/>
          </p:nvSpPr>
          <p:spPr>
            <a:xfrm flipH="1">
              <a:off x="1111680" y="2840400"/>
              <a:ext cx="175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headEnd len="med" type="stealth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1"/>
            <p:cNvSpPr/>
            <p:nvPr/>
          </p:nvSpPr>
          <p:spPr>
            <a:xfrm>
              <a:off x="3404880" y="436104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2"/>
            <p:cNvSpPr/>
            <p:nvPr/>
          </p:nvSpPr>
          <p:spPr>
            <a:xfrm>
              <a:off x="3404880" y="497772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3"/>
            <p:cNvSpPr/>
            <p:nvPr/>
          </p:nvSpPr>
          <p:spPr>
            <a:xfrm>
              <a:off x="3404880" y="5477040"/>
              <a:ext cx="61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2" name="Picture 24" descr=""/>
            <p:cNvPicPr/>
            <p:nvPr/>
          </p:nvPicPr>
          <p:blipFill>
            <a:blip r:embed="rId1"/>
            <a:stretch/>
          </p:blipFill>
          <p:spPr>
            <a:xfrm>
              <a:off x="1315440" y="788760"/>
              <a:ext cx="2124000" cy="4976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Line 25"/>
            <p:cNvSpPr/>
            <p:nvPr/>
          </p:nvSpPr>
          <p:spPr>
            <a:xfrm>
              <a:off x="3544200" y="3336120"/>
              <a:ext cx="318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26"/>
            <p:cNvSpPr/>
            <p:nvPr/>
          </p:nvSpPr>
          <p:spPr>
            <a:xfrm>
              <a:off x="3942000" y="613080"/>
              <a:ext cx="318240" cy="5119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5’CATTACTATTCTCCGACACACACACTGAGCA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7"/>
            <p:cNvSpPr/>
            <p:nvPr/>
          </p:nvSpPr>
          <p:spPr>
            <a:xfrm flipV="1">
              <a:off x="3862440" y="788760"/>
              <a:ext cx="79560" cy="1591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8"/>
            <p:cNvSpPr/>
            <p:nvPr/>
          </p:nvSpPr>
          <p:spPr>
            <a:xfrm>
              <a:off x="3862440" y="3336120"/>
              <a:ext cx="79560" cy="2547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29"/>
            <p:cNvSpPr/>
            <p:nvPr/>
          </p:nvSpPr>
          <p:spPr>
            <a:xfrm>
              <a:off x="3544200" y="2381040"/>
              <a:ext cx="318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0"/>
            <p:cNvSpPr/>
            <p:nvPr/>
          </p:nvSpPr>
          <p:spPr>
            <a:xfrm flipH="1">
              <a:off x="4180680" y="2699280"/>
              <a:ext cx="175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1"/>
            <p:cNvSpPr/>
            <p:nvPr/>
          </p:nvSpPr>
          <p:spPr>
            <a:xfrm flipH="1">
              <a:off x="4180680" y="3177000"/>
              <a:ext cx="175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ine 32"/>
            <p:cNvSpPr/>
            <p:nvPr/>
          </p:nvSpPr>
          <p:spPr>
            <a:xfrm flipH="1">
              <a:off x="4180680" y="5883120"/>
              <a:ext cx="175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3"/>
            <p:cNvSpPr/>
            <p:nvPr/>
          </p:nvSpPr>
          <p:spPr>
            <a:xfrm>
              <a:off x="4260600" y="2540160"/>
              <a:ext cx="795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-20 TSS        Bn-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</a:rPr>
                <a:t>FAE1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34"/>
            <p:cNvSpPr/>
            <p:nvPr/>
          </p:nvSpPr>
          <p:spPr>
            <a:xfrm>
              <a:off x="4260600" y="3017520"/>
              <a:ext cx="795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-17 TSS    Bn-</a:t>
              </a:r>
              <a:r>
                <a:rPr b="1" i="1" lang="fr-FR" sz="800" spc="-1" strike="noStrike">
                  <a:solidFill>
                    <a:srgbClr val="000000"/>
                  </a:solidFill>
                  <a:latin typeface="Arial"/>
                </a:rPr>
                <a:t>FAE1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35"/>
            <p:cNvSpPr/>
            <p:nvPr/>
          </p:nvSpPr>
          <p:spPr>
            <a:xfrm>
              <a:off x="4260600" y="5724000"/>
              <a:ext cx="477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+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Grouper 47"/>
            <p:cNvGrpSpPr/>
            <p:nvPr/>
          </p:nvGrpSpPr>
          <p:grpSpPr>
            <a:xfrm>
              <a:off x="1315440" y="788760"/>
              <a:ext cx="2148840" cy="5016240"/>
              <a:chOff x="1315440" y="788760"/>
              <a:chExt cx="2148840" cy="5016240"/>
            </a:xfrm>
          </p:grpSpPr>
          <p:sp>
            <p:nvSpPr>
              <p:cNvPr id="75" name="Connecteur droit 40"/>
              <p:cNvSpPr/>
              <p:nvPr/>
            </p:nvSpPr>
            <p:spPr>
              <a:xfrm>
                <a:off x="1315440" y="788760"/>
                <a:ext cx="21488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Connecteur droit 43"/>
              <p:cNvSpPr/>
              <p:nvPr/>
            </p:nvSpPr>
            <p:spPr>
              <a:xfrm>
                <a:off x="1315440" y="5803560"/>
                <a:ext cx="21488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Connecteur droit 45"/>
              <p:cNvSpPr/>
              <p:nvPr/>
            </p:nvSpPr>
            <p:spPr>
              <a:xfrm flipH="1">
                <a:off x="1315440" y="789480"/>
                <a:ext cx="1440" cy="5014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Connecteur droit 46"/>
              <p:cNvSpPr/>
              <p:nvPr/>
            </p:nvSpPr>
            <p:spPr>
              <a:xfrm flipH="1">
                <a:off x="3462840" y="788760"/>
                <a:ext cx="1440" cy="5014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Connecteur droit 49"/>
            <p:cNvSpPr/>
            <p:nvPr/>
          </p:nvSpPr>
          <p:spPr>
            <a:xfrm>
              <a:off x="2429640" y="548280"/>
              <a:ext cx="795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ZoneTexte 39"/>
          <p:cNvSpPr/>
          <p:nvPr/>
        </p:nvSpPr>
        <p:spPr>
          <a:xfrm>
            <a:off x="609480" y="5899320"/>
            <a:ext cx="5639040" cy="29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dditional file 1. Transcription start site mapping of the 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Brassica napus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Products of the primer extension reactions were resolved on a 5% sequencing gel and their sizes are indicated on the left. Lane 1, Bn-FAE1.2 transcript; Lane 2, Bn-FAE1.1 transcript; Lanes 3 and 4, yeast tRNA negative control reactions. Bn-FAE1.1 indicates 5’ flanking cDNA sequence ladder (lanes G, A, T, C) generated by the same primers. M indicates size marker ladder generated from a radiolabelled HpaII digested pBR322 plasmid. The sense sequence in the proximity of the cDNA products is shown on the right and the transcription start sites are indicated by arrows. A major extension product of 143 nucleotides was obtained with the CE17 primer complementary to the CE7 mRNA,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.1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 (lane 1). A major extension product of 146 nucleotides was obtained with the CE18 primer complementary to the CE8 mRNA,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.2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 (lane 2). A minor extension product of 251 nucleotides corresponding to a TSS at -125 was obtained corresponding to a secondary transcription product of the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.2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. No extension products were obtained from either primer with yeast RNA, (lanes 3 and 4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 major extension product of 143 nucleotides was obtained with the CE17 primer complementary to the CE7 mRNA,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.1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 (lane 1). A major extension product of 146 nucleotides was obtained with the CE18 primer complementary to the CE8 mRNA,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.2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 (lane 2). A minor extension product of 251 nucleotides corresponding to a TSS at -125 was obtained corresponding to a secondary transcription product of the Bn-</a:t>
            </a:r>
            <a:r>
              <a:rPr b="0" i="1" lang="en-GB" sz="1000" spc="-1" strike="noStrike">
                <a:solidFill>
                  <a:srgbClr val="000000"/>
                </a:solidFill>
                <a:latin typeface="Arial"/>
              </a:rPr>
              <a:t>FAE1.2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 gene. No extension products were obtained from either primer with yeast RNA, (lanes 3 and 4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3-29T12:44:57Z</dcterms:created>
  <dc:creator>UMR5096</dc:creator>
  <dc:description/>
  <dc:language>en-US</dc:language>
  <cp:lastModifiedBy>UMR5096</cp:lastModifiedBy>
  <cp:lastPrinted>2013-08-24T09:53:38Z</cp:lastPrinted>
  <dcterms:modified xsi:type="dcterms:W3CDTF">2015-02-18T16:17:36Z</dcterms:modified>
  <cp:revision>12</cp:revision>
  <dc:subject/>
  <dc:title>Présentation PowerPoint</dc:title>
</cp:coreProperties>
</file>